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47.xml" ContentType="application/vnd.ms-office.chartstyle+xml"/>
  <Override PartName="/ppt/charts/colors47.xml" ContentType="application/vnd.ms-office.chartcolorstyle+xml"/>
  <Override PartName="/ppt/charts/style48.xml" ContentType="application/vnd.ms-office.chartstyle+xml"/>
  <Override PartName="/ppt/charts/colors48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75"/>
    <p:restoredTop sz="94194"/>
  </p:normalViewPr>
  <p:slideViewPr>
    <p:cSldViewPr snapToGrid="0" snapToObjects="1">
      <p:cViewPr>
        <p:scale>
          <a:sx n="100" d="100"/>
          <a:sy n="100" d="100"/>
        </p:scale>
        <p:origin x="-1236" y="-32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47.xml"/><Relationship Id="rId2" Type="http://schemas.microsoft.com/office/2011/relationships/chartColorStyle" Target="colors47.xml"/><Relationship Id="rId1" Type="http://schemas.openxmlformats.org/officeDocument/2006/relationships/oleObject" Target="file:///\\Users\Bella\Dropbox\PhD%20write-up%202018%20Bella%20Maudlin\Results\Chapter%203\Figures%20results%20chapter%203\Figure%207%20results%20chapter%203\16.8.17%20growth%20analyses%20spt5%20wt%20mutants%20and%20bur1%20bur2%20(COPY)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48.xml"/><Relationship Id="rId2" Type="http://schemas.microsoft.com/office/2011/relationships/chartColorStyle" Target="colors48.xml"/><Relationship Id="rId1" Type="http://schemas.openxmlformats.org/officeDocument/2006/relationships/oleObject" Target="file:///\\Volumes\BELLA\6.5.18%20GROWTH%20ANALYSES%20ALL%20STRAIN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BUR1 BUR2 AUXIN'!$W$3:$W$19</c:f>
              <c:numCache>
                <c:formatCode>General</c:formatCode>
                <c:ptCount val="17"/>
                <c:pt idx="0">
                  <c:v>0.19600000000000004</c:v>
                </c:pt>
                <c:pt idx="1">
                  <c:v>0.24233333333333332</c:v>
                </c:pt>
                <c:pt idx="2">
                  <c:v>0.29699999999999999</c:v>
                </c:pt>
                <c:pt idx="3">
                  <c:v>0.41399999999999998</c:v>
                </c:pt>
                <c:pt idx="4">
                  <c:v>0.62299999999999989</c:v>
                </c:pt>
                <c:pt idx="5">
                  <c:v>0.92799999999999994</c:v>
                </c:pt>
                <c:pt idx="6">
                  <c:v>1.2629999999999999</c:v>
                </c:pt>
                <c:pt idx="7">
                  <c:v>1.4336666666666666</c:v>
                </c:pt>
                <c:pt idx="8">
                  <c:v>1.4880000000000002</c:v>
                </c:pt>
                <c:pt idx="9">
                  <c:v>1.5173333333333332</c:v>
                </c:pt>
                <c:pt idx="10">
                  <c:v>1.5623333333333334</c:v>
                </c:pt>
                <c:pt idx="11">
                  <c:v>1.5986666666666665</c:v>
                </c:pt>
                <c:pt idx="12">
                  <c:v>1.6283333333333332</c:v>
                </c:pt>
                <c:pt idx="13">
                  <c:v>1.649</c:v>
                </c:pt>
                <c:pt idx="14">
                  <c:v>1.6610000000000003</c:v>
                </c:pt>
                <c:pt idx="15">
                  <c:v>1.6776666666666669</c:v>
                </c:pt>
                <c:pt idx="16">
                  <c:v>1.683999999999999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8346-7744-84BD-BA55CA626847}"/>
            </c:ext>
          </c:extLst>
        </c:ser>
        <c:ser>
          <c:idx val="1"/>
          <c:order val="1"/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val>
            <c:numRef>
              <c:f>'BUR1 BUR2 AUXIN'!$X$3:$X$19</c:f>
              <c:numCache>
                <c:formatCode>General</c:formatCode>
                <c:ptCount val="17"/>
                <c:pt idx="0">
                  <c:v>0.19466666666666668</c:v>
                </c:pt>
                <c:pt idx="1">
                  <c:v>0.23266666666666666</c:v>
                </c:pt>
                <c:pt idx="2">
                  <c:v>0.27500000000000002</c:v>
                </c:pt>
                <c:pt idx="3">
                  <c:v>0.36866666666666664</c:v>
                </c:pt>
                <c:pt idx="4">
                  <c:v>0.53466666666666673</c:v>
                </c:pt>
                <c:pt idx="5">
                  <c:v>0.80033333333333323</c:v>
                </c:pt>
                <c:pt idx="6">
                  <c:v>1.1173333333333333</c:v>
                </c:pt>
                <c:pt idx="7">
                  <c:v>1.3883333333333334</c:v>
                </c:pt>
                <c:pt idx="8">
                  <c:v>1.4753333333333334</c:v>
                </c:pt>
                <c:pt idx="9">
                  <c:v>1.51</c:v>
                </c:pt>
                <c:pt idx="10">
                  <c:v>1.5506666666666666</c:v>
                </c:pt>
                <c:pt idx="11">
                  <c:v>1.5906666666666667</c:v>
                </c:pt>
                <c:pt idx="12">
                  <c:v>1.6246666666666669</c:v>
                </c:pt>
                <c:pt idx="13">
                  <c:v>1.6459999999999999</c:v>
                </c:pt>
                <c:pt idx="14">
                  <c:v>1.6619999999999999</c:v>
                </c:pt>
                <c:pt idx="15">
                  <c:v>1.6766666666666667</c:v>
                </c:pt>
                <c:pt idx="16">
                  <c:v>1.684666666666666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8346-7744-84BD-BA55CA6268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8621824"/>
        <c:axId val="108623360"/>
      </c:lineChart>
      <c:catAx>
        <c:axId val="10862182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8623360"/>
        <c:crosses val="autoZero"/>
        <c:auto val="1"/>
        <c:lblAlgn val="ctr"/>
        <c:lblOffset val="100"/>
        <c:noMultiLvlLbl val="0"/>
      </c:catAx>
      <c:valAx>
        <c:axId val="108623360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8621824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val>
            <c:numRef>
              <c:f>'BUR1 BUR2 CTK1 PAF1'!$T$39:$T$53</c:f>
              <c:numCache>
                <c:formatCode>General</c:formatCode>
                <c:ptCount val="15"/>
                <c:pt idx="0">
                  <c:v>0.19299999999999998</c:v>
                </c:pt>
                <c:pt idx="1">
                  <c:v>0.19966666666666666</c:v>
                </c:pt>
                <c:pt idx="2">
                  <c:v>0.21833333333333335</c:v>
                </c:pt>
                <c:pt idx="3">
                  <c:v>0.25666666666666665</c:v>
                </c:pt>
                <c:pt idx="4">
                  <c:v>0.33633333333333337</c:v>
                </c:pt>
                <c:pt idx="5">
                  <c:v>0.47800000000000004</c:v>
                </c:pt>
                <c:pt idx="6">
                  <c:v>0.56266666666666676</c:v>
                </c:pt>
                <c:pt idx="7">
                  <c:v>0.77366666666666661</c:v>
                </c:pt>
                <c:pt idx="8">
                  <c:v>1.1603333333333332</c:v>
                </c:pt>
                <c:pt idx="9">
                  <c:v>1.2226666666666668</c:v>
                </c:pt>
                <c:pt idx="10">
                  <c:v>1.2986666666666666</c:v>
                </c:pt>
                <c:pt idx="11">
                  <c:v>1.3916666666666666</c:v>
                </c:pt>
                <c:pt idx="12">
                  <c:v>1.4873333333333332</c:v>
                </c:pt>
                <c:pt idx="13">
                  <c:v>1.5683333333333334</c:v>
                </c:pt>
                <c:pt idx="14">
                  <c:v>1.636666666666666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6E95-8F41-B672-36F0166E3F73}"/>
            </c:ext>
          </c:extLst>
        </c:ser>
        <c:ser>
          <c:idx val="2"/>
          <c:order val="1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val>
            <c:numRef>
              <c:f>'BUR1 BUR2 CTK1 PAF1'!$X$2:$X$16</c:f>
              <c:numCache>
                <c:formatCode>General</c:formatCode>
                <c:ptCount val="15"/>
                <c:pt idx="0">
                  <c:v>0.19499999999999998</c:v>
                </c:pt>
                <c:pt idx="1">
                  <c:v>0.20199999999999999</c:v>
                </c:pt>
                <c:pt idx="2">
                  <c:v>0.22299999999999998</c:v>
                </c:pt>
                <c:pt idx="3">
                  <c:v>0.26500000000000001</c:v>
                </c:pt>
                <c:pt idx="4">
                  <c:v>0.35066666666666668</c:v>
                </c:pt>
                <c:pt idx="5">
                  <c:v>0.5013333333333333</c:v>
                </c:pt>
                <c:pt idx="6">
                  <c:v>0.63800000000000001</c:v>
                </c:pt>
                <c:pt idx="7">
                  <c:v>0.86499999999999988</c:v>
                </c:pt>
                <c:pt idx="8">
                  <c:v>1.0833333333333333</c:v>
                </c:pt>
                <c:pt idx="9">
                  <c:v>1.1866666666666668</c:v>
                </c:pt>
                <c:pt idx="10">
                  <c:v>1.2569999999999999</c:v>
                </c:pt>
                <c:pt idx="11">
                  <c:v>1.3413333333333333</c:v>
                </c:pt>
                <c:pt idx="12">
                  <c:v>1.4370000000000001</c:v>
                </c:pt>
                <c:pt idx="13">
                  <c:v>1.5269999999999999</c:v>
                </c:pt>
                <c:pt idx="14">
                  <c:v>1.602333333333333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6E95-8F41-B672-36F0166E3F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8653568"/>
        <c:axId val="108655360"/>
      </c:lineChart>
      <c:catAx>
        <c:axId val="10865356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8655360"/>
        <c:crosses val="autoZero"/>
        <c:auto val="1"/>
        <c:lblAlgn val="ctr"/>
        <c:lblOffset val="100"/>
        <c:noMultiLvlLbl val="0"/>
      </c:catAx>
      <c:valAx>
        <c:axId val="108655360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865356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4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4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8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="" xmlns:a16="http://schemas.microsoft.com/office/drawing/2014/main" id="{AE52DE9F-C0FA-E748-8EC1-37EA442AD083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59363806-4A4D-C74B-8FB0-80D81104C6C5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1E85D9-D9AB-C24E-9F2A-03055CB7B865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1B573569-A563-B84E-A725-E429CD13D740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75CF8488-4134-EE41-A18B-70CD4A7DC1FE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447B02-EB5F-6A4A-AE8B-33CE3BE4EE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4114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22E6C0-0B9D-F14C-84DD-337F507B5466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4A6A5C-AAF6-7A41-AD4A-8667EF1760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40169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B7B89-C015-1240-B258-F30F47AC7496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9C19B-F665-6247-9F88-9E7E6D4A40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938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B7B89-C015-1240-B258-F30F47AC7496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9C19B-F665-6247-9F88-9E7E6D4A40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4063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B7B89-C015-1240-B258-F30F47AC7496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9C19B-F665-6247-9F88-9E7E6D4A40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6782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B7B89-C015-1240-B258-F30F47AC7496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9C19B-F665-6247-9F88-9E7E6D4A40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410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B7B89-C015-1240-B258-F30F47AC7496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9C19B-F665-6247-9F88-9E7E6D4A40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1513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B7B89-C015-1240-B258-F30F47AC7496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9C19B-F665-6247-9F88-9E7E6D4A40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3321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B7B89-C015-1240-B258-F30F47AC7496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9C19B-F665-6247-9F88-9E7E6D4A40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6303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B7B89-C015-1240-B258-F30F47AC7496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9C19B-F665-6247-9F88-9E7E6D4A40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74786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B7B89-C015-1240-B258-F30F47AC7496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9C19B-F665-6247-9F88-9E7E6D4A40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7833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B7B89-C015-1240-B258-F30F47AC7496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9C19B-F665-6247-9F88-9E7E6D4A40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481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B7B89-C015-1240-B258-F30F47AC7496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9C19B-F665-6247-9F88-9E7E6D4A40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977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8B7B89-C015-1240-B258-F30F47AC7496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09C19B-F665-6247-9F88-9E7E6D4A40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2754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="" xmlns:a16="http://schemas.microsoft.com/office/drawing/2014/main" id="{FF2763F9-BBE2-A543-A29E-F8D2EEF661CB}"/>
              </a:ext>
            </a:extLst>
          </p:cNvPr>
          <p:cNvSpPr txBox="1"/>
          <p:nvPr/>
        </p:nvSpPr>
        <p:spPr>
          <a:xfrm>
            <a:off x="1414403" y="1264074"/>
            <a:ext cx="20211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DH1-409-TIR1 (parental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="" xmlns:a16="http://schemas.microsoft.com/office/drawing/2014/main" id="{8ECA18FC-3C6B-0B47-96B8-5D93FC8D8DA8}"/>
              </a:ext>
            </a:extLst>
          </p:cNvPr>
          <p:cNvSpPr txBox="1"/>
          <p:nvPr/>
        </p:nvSpPr>
        <p:spPr>
          <a:xfrm>
            <a:off x="1430523" y="1416003"/>
            <a:ext cx="1524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ur1-AID*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="" xmlns:a16="http://schemas.microsoft.com/office/drawing/2014/main" id="{52926D05-7704-684B-97FF-34158C4E3452}"/>
              </a:ext>
            </a:extLst>
          </p:cNvPr>
          <p:cNvCxnSpPr>
            <a:cxnSpLocks/>
          </p:cNvCxnSpPr>
          <p:nvPr/>
        </p:nvCxnSpPr>
        <p:spPr>
          <a:xfrm>
            <a:off x="1178050" y="1395406"/>
            <a:ext cx="272257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064DE346-3115-A241-B035-0A452D9EBBF7}"/>
              </a:ext>
            </a:extLst>
          </p:cNvPr>
          <p:cNvSpPr txBox="1"/>
          <p:nvPr/>
        </p:nvSpPr>
        <p:spPr>
          <a:xfrm>
            <a:off x="1649240" y="3436661"/>
            <a:ext cx="54345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marR="0" lvl="0" indent="-28575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Symbol" charset="2"/>
              <a:buNone/>
              <a:tabLst/>
              <a:defRPr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ime (hours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="" xmlns:a16="http://schemas.microsoft.com/office/drawing/2014/main" id="{3624E557-BF88-324A-BE4D-18B8DDC69C29}"/>
              </a:ext>
            </a:extLst>
          </p:cNvPr>
          <p:cNvSpPr txBox="1"/>
          <p:nvPr/>
        </p:nvSpPr>
        <p:spPr>
          <a:xfrm rot="16200000">
            <a:off x="-808480" y="1028642"/>
            <a:ext cx="30937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marR="0" lvl="0" indent="-28575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Symbol" charset="2"/>
              <a:buNone/>
              <a:tabLst/>
              <a:defRPr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</a:p>
        </p:txBody>
      </p:sp>
      <p:graphicFrame>
        <p:nvGraphicFramePr>
          <p:cNvPr id="25" name="Chart 24">
            <a:extLst>
              <a:ext uri="{FF2B5EF4-FFF2-40B4-BE49-F238E27FC236}">
                <a16:creationId xmlns="" xmlns:a16="http://schemas.microsoft.com/office/drawing/2014/main" id="{A4D61E85-2DF7-9545-9D62-84A696EEF64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28487393"/>
              </p:ext>
            </p:extLst>
          </p:nvPr>
        </p:nvGraphicFramePr>
        <p:xfrm>
          <a:off x="829374" y="1647773"/>
          <a:ext cx="2307125" cy="18075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27" name="Straight Connector 26">
            <a:extLst>
              <a:ext uri="{FF2B5EF4-FFF2-40B4-BE49-F238E27FC236}">
                <a16:creationId xmlns="" xmlns:a16="http://schemas.microsoft.com/office/drawing/2014/main" id="{91F1D3D9-781C-5449-AEC2-842A2BF6C801}"/>
              </a:ext>
            </a:extLst>
          </p:cNvPr>
          <p:cNvCxnSpPr>
            <a:cxnSpLocks/>
          </p:cNvCxnSpPr>
          <p:nvPr/>
        </p:nvCxnSpPr>
        <p:spPr>
          <a:xfrm>
            <a:off x="1178049" y="1543356"/>
            <a:ext cx="272257" cy="0"/>
          </a:xfrm>
          <a:prstGeom prst="line">
            <a:avLst/>
          </a:prstGeom>
          <a:ln w="38100"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Rectangle 4">
            <a:extLst>
              <a:ext uri="{FF2B5EF4-FFF2-40B4-BE49-F238E27FC236}">
                <a16:creationId xmlns="" xmlns:a16="http://schemas.microsoft.com/office/drawing/2014/main" id="{99ED8470-DC86-0842-BEB2-FE46F3905342}"/>
              </a:ext>
            </a:extLst>
          </p:cNvPr>
          <p:cNvSpPr/>
          <p:nvPr/>
        </p:nvSpPr>
        <p:spPr>
          <a:xfrm>
            <a:off x="2344152" y="347532"/>
            <a:ext cx="614533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graphicFrame>
        <p:nvGraphicFramePr>
          <p:cNvPr id="30" name="Chart 29">
            <a:extLst>
              <a:ext uri="{FF2B5EF4-FFF2-40B4-BE49-F238E27FC236}">
                <a16:creationId xmlns="" xmlns:a16="http://schemas.microsoft.com/office/drawing/2014/main" id="{96750268-61A4-E944-A682-AB100F0BD02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64130737"/>
              </p:ext>
            </p:extLst>
          </p:nvPr>
        </p:nvGraphicFramePr>
        <p:xfrm>
          <a:off x="3908242" y="1647772"/>
          <a:ext cx="2307125" cy="18202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2" name="TextBox 31">
            <a:extLst>
              <a:ext uri="{FF2B5EF4-FFF2-40B4-BE49-F238E27FC236}">
                <a16:creationId xmlns="" xmlns:a16="http://schemas.microsoft.com/office/drawing/2014/main" id="{E6447C9F-96E1-AD44-96E7-37A05215E75C}"/>
              </a:ext>
            </a:extLst>
          </p:cNvPr>
          <p:cNvSpPr txBox="1"/>
          <p:nvPr/>
        </p:nvSpPr>
        <p:spPr>
          <a:xfrm>
            <a:off x="4800730" y="3436661"/>
            <a:ext cx="54345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marR="0" lvl="0" indent="-28575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Symbol" charset="2"/>
              <a:buNone/>
              <a:tabLst/>
              <a:defRPr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ime (hours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="" xmlns:a16="http://schemas.microsoft.com/office/drawing/2014/main" id="{892E7003-7B39-194D-9A28-83806667FF7F}"/>
              </a:ext>
            </a:extLst>
          </p:cNvPr>
          <p:cNvSpPr txBox="1"/>
          <p:nvPr/>
        </p:nvSpPr>
        <p:spPr>
          <a:xfrm rot="16200000">
            <a:off x="2297732" y="1027228"/>
            <a:ext cx="30937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marR="0" lvl="0" indent="-28575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Symbol" charset="2"/>
              <a:buNone/>
              <a:tabLst/>
              <a:defRPr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="" xmlns:a16="http://schemas.microsoft.com/office/drawing/2014/main" id="{AB8B03FB-352C-1D4D-A334-D164D7449D89}"/>
              </a:ext>
            </a:extLst>
          </p:cNvPr>
          <p:cNvSpPr txBox="1"/>
          <p:nvPr/>
        </p:nvSpPr>
        <p:spPr>
          <a:xfrm>
            <a:off x="4508782" y="1264074"/>
            <a:ext cx="1816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DH1-409-TIR1 (parental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="" xmlns:a16="http://schemas.microsoft.com/office/drawing/2014/main" id="{B6C7A7DE-ECDB-0E44-BC9D-724E3D245507}"/>
              </a:ext>
            </a:extLst>
          </p:cNvPr>
          <p:cNvSpPr txBox="1"/>
          <p:nvPr/>
        </p:nvSpPr>
        <p:spPr>
          <a:xfrm>
            <a:off x="4524901" y="1416003"/>
            <a:ext cx="1524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tk1-AID*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="" xmlns:a16="http://schemas.microsoft.com/office/drawing/2014/main" id="{DB6019D6-772F-3C47-B670-72A2188720AB}"/>
              </a:ext>
            </a:extLst>
          </p:cNvPr>
          <p:cNvCxnSpPr>
            <a:cxnSpLocks/>
          </p:cNvCxnSpPr>
          <p:nvPr/>
        </p:nvCxnSpPr>
        <p:spPr>
          <a:xfrm>
            <a:off x="4272428" y="1395406"/>
            <a:ext cx="272257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="" xmlns:a16="http://schemas.microsoft.com/office/drawing/2014/main" id="{BA02DE80-25D5-4346-8B47-F3B3690B724C}"/>
              </a:ext>
            </a:extLst>
          </p:cNvPr>
          <p:cNvCxnSpPr>
            <a:cxnSpLocks/>
          </p:cNvCxnSpPr>
          <p:nvPr/>
        </p:nvCxnSpPr>
        <p:spPr>
          <a:xfrm>
            <a:off x="4272427" y="1543356"/>
            <a:ext cx="272257" cy="0"/>
          </a:xfrm>
          <a:prstGeom prst="line">
            <a:avLst/>
          </a:prstGeom>
          <a:ln w="38100"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1349409B-F838-A547-9D69-BCB6A1C256A6}"/>
              </a:ext>
            </a:extLst>
          </p:cNvPr>
          <p:cNvSpPr txBox="1"/>
          <p:nvPr/>
        </p:nvSpPr>
        <p:spPr>
          <a:xfrm>
            <a:off x="211220" y="1539114"/>
            <a:ext cx="152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2CE50ACA-3745-7C45-9283-79F12691FC3E}"/>
              </a:ext>
            </a:extLst>
          </p:cNvPr>
          <p:cNvSpPr txBox="1"/>
          <p:nvPr/>
        </p:nvSpPr>
        <p:spPr>
          <a:xfrm>
            <a:off x="3493355" y="1539971"/>
            <a:ext cx="152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5443890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83</TotalTime>
  <Words>27</Words>
  <Application>Microsoft Office PowerPoint</Application>
  <PresentationFormat>A4 Paper (210x297 mm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UDLIN Isabella</dc:creator>
  <cp:lastModifiedBy>is8829</cp:lastModifiedBy>
  <cp:revision>161</cp:revision>
  <cp:lastPrinted>2019-02-06T11:33:33Z</cp:lastPrinted>
  <dcterms:created xsi:type="dcterms:W3CDTF">2019-01-30T14:59:01Z</dcterms:created>
  <dcterms:modified xsi:type="dcterms:W3CDTF">2021-10-08T08:39:19Z</dcterms:modified>
</cp:coreProperties>
</file>